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352" r:id="rId2"/>
    <p:sldId id="256" r:id="rId3"/>
    <p:sldId id="350" r:id="rId4"/>
    <p:sldId id="351" r:id="rId5"/>
    <p:sldId id="349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94"/>
  </p:normalViewPr>
  <p:slideViewPr>
    <p:cSldViewPr snapToGrid="0" snapToObjects="1">
      <p:cViewPr varScale="1">
        <p:scale>
          <a:sx n="77" d="100"/>
          <a:sy n="77" d="100"/>
        </p:scale>
        <p:origin x="319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F6714D-3754-BE46-9226-CB2B9588B24E}" type="datetimeFigureOut">
              <a:rPr lang="en-US" smtClean="0"/>
              <a:t>5/2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F3A9CD-12D9-894E-B8D2-F9F2713C2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208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5221CD-7B6A-674E-B388-09C704CE577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286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212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749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168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943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552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404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52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351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984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132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555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54C0AA-A8DA-C847-8C5D-A8A8B3437D56}" type="datetimeFigureOut">
              <a:rPr lang="en-US" smtClean="0"/>
              <a:t>5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ABC27-CC3A-6041-8925-A1E947D871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48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mailto:alan.levett@uqconnect.edu.a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95B33B2-C291-6B4D-90F0-060B730BE5B4}"/>
              </a:ext>
            </a:extLst>
          </p:cNvPr>
          <p:cNvSpPr/>
          <p:nvPr/>
        </p:nvSpPr>
        <p:spPr>
          <a:xfrm>
            <a:off x="403167" y="1080017"/>
            <a:ext cx="6051666" cy="53040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AU" sz="1400" kern="1400" spc="-5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materials related to:</a:t>
            </a:r>
          </a:p>
          <a:p>
            <a:pPr algn="ctr">
              <a:spcAft>
                <a:spcPts val="0"/>
              </a:spcAft>
            </a:pPr>
            <a:endParaRPr lang="en-AU" sz="1400" kern="1400" spc="-5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endParaRPr lang="en-AU" sz="1400" kern="1400" spc="-5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endParaRPr lang="en-AU" sz="1400" kern="1400" spc="-5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AU" sz="2800" kern="1400" spc="-5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racterisation of iron oxide encrusted microbial fossils</a:t>
            </a:r>
          </a:p>
          <a:p>
            <a:pPr algn="ctr">
              <a:spcAft>
                <a:spcPts val="0"/>
              </a:spcAft>
            </a:pPr>
            <a:endParaRPr lang="en-AU" sz="2800" kern="1400" spc="-5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endParaRPr lang="en-AU" sz="2800" kern="1400" spc="-5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endParaRPr lang="en-AU" sz="2800" kern="1400" spc="-5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Scientific Reports</a:t>
            </a: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AU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an </a:t>
            </a:r>
            <a:r>
              <a:rPr lang="en-AU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vett</a:t>
            </a:r>
            <a:r>
              <a:rPr lang="en-AU" sz="16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AU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AU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mma J. </a:t>
            </a:r>
            <a:r>
              <a:rPr lang="en-AU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gen</a:t>
            </a:r>
            <a:r>
              <a:rPr lang="en-AU" sz="16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AU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AU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lew</a:t>
            </a:r>
            <a:r>
              <a:rPr lang="en-AU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intoul</a:t>
            </a:r>
            <a:r>
              <a:rPr lang="en-AU" sz="16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AU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aul </a:t>
            </a:r>
            <a:r>
              <a:rPr lang="en-AU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uagliardo</a:t>
            </a:r>
            <a:r>
              <a:rPr lang="en-AU" sz="16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AU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ui </a:t>
            </a:r>
            <a:r>
              <a:rPr lang="en-AU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ao</a:t>
            </a:r>
            <a:r>
              <a:rPr lang="en-AU" sz="16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AU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aulo M. </a:t>
            </a:r>
            <a:r>
              <a:rPr lang="en-AU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sconcelos</a:t>
            </a:r>
            <a:r>
              <a:rPr lang="en-AU" sz="16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AU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Gordon </a:t>
            </a:r>
            <a:r>
              <a:rPr lang="en-AU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utham</a:t>
            </a:r>
            <a:r>
              <a:rPr lang="en-AU" sz="16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AU" sz="1600" baseline="30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endParaRPr lang="en-AU" sz="1400" baseline="30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author to whom correspondence should be directed: </a:t>
            </a:r>
            <a:r>
              <a:rPr lang="en-AU" sz="1200" u="sng" dirty="0"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alan.levett@uqconnect.edu.au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AU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B1EE7FF-60F9-4643-8025-99EDB20FDA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93950" y="3166082"/>
            <a:ext cx="2070100" cy="977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0703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5" name="Table 4">
                <a:extLst>
                  <a:ext uri="{FF2B5EF4-FFF2-40B4-BE49-F238E27FC236}">
                    <a16:creationId xmlns:a16="http://schemas.microsoft.com/office/drawing/2014/main" id="{D31328EC-656B-AA45-8C4A-B480A2D7D854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2900898849"/>
                  </p:ext>
                </p:extLst>
              </p:nvPr>
            </p:nvGraphicFramePr>
            <p:xfrm>
              <a:off x="574662" y="2064639"/>
              <a:ext cx="5852769" cy="3601720"/>
            </p:xfrm>
            <a:graphic>
              <a:graphicData uri="http://schemas.openxmlformats.org/drawingml/2006/table">
                <a:tbl>
                  <a:tblPr firstRow="1" bandRow="1">
                    <a:tableStyleId>{5940675A-B579-460E-94D1-54222C63F5DA}</a:tableStyleId>
                  </a:tblPr>
                  <a:tblGrid>
                    <a:gridCol w="1789811">
                      <a:extLst>
                        <a:ext uri="{9D8B030D-6E8A-4147-A177-3AD203B41FA5}">
                          <a16:colId xmlns:a16="http://schemas.microsoft.com/office/drawing/2014/main" val="747991374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739714215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45241243"/>
                        </a:ext>
                      </a:extLst>
                    </a:gridCol>
                    <a:gridCol w="797243">
                      <a:extLst>
                        <a:ext uri="{9D8B030D-6E8A-4147-A177-3AD203B41FA5}">
                          <a16:colId xmlns:a16="http://schemas.microsoft.com/office/drawing/2014/main" val="3087449460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3246340764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1171635718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1484073801"/>
                        </a:ext>
                      </a:extLst>
                    </a:gridCol>
                  </a:tblGrid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inerals in samples</a:t>
                          </a:r>
                        </a:p>
                      </a:txBody>
                      <a:tcPr/>
                    </a:tc>
                    <a:tc gridSpan="6"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Wavenumbers (cm</a:t>
                          </a:r>
                          <a:r>
                            <a:rPr lang="en-US" baseline="30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1</a:t>
                          </a:r>
                          <a:r>
                            <a:rPr lang="en-US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)</a:t>
                          </a:r>
                          <a:endParaRPr lang="en-US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398875660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Goethite [α-</a:t>
                          </a:r>
                          <a:r>
                            <a:rPr lang="en-US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FeOOH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44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99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8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48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54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81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2308452441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Lepidocrocite </a:t>
                          </a:r>
                        </a:p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[</a:t>
                          </a:r>
                          <a14:m>
                            <m:oMath xmlns:m="http://schemas.openxmlformats.org/officeDocument/2006/math">
                              <m:r>
                                <a:rPr lang="en-AU" sz="1350" i="1" kern="1200" smtClean="0">
                                  <a:solidFill>
                                    <a:schemeClr val="tx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𝛾</m:t>
                              </m:r>
                            </m:oMath>
                          </a14:m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  <a:r>
                            <a:rPr lang="en-US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FeOOH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5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4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79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52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5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2623539500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ssociated minerals not observed</a:t>
                          </a:r>
                        </a:p>
                      </a:txBody>
                      <a:tcPr/>
                    </a:tc>
                    <a:tc gridSpan="6">
                      <a:txBody>
                        <a:bodyPr/>
                        <a:lstStyle/>
                        <a:p>
                          <a:pPr algn="ctr"/>
                          <a:endParaRPr lang="en-US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76155384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Hematite [Fe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O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</a:t>
                          </a:r>
                          <a:r>
                            <a:rPr lang="en-US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  <a:endParaRPr lang="en-US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2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4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90-30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412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3093942682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Rutile [TiO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44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12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2230308384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marL="0" marR="0" lvl="0" indent="0" algn="ctr" defTabSz="6858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atase [TiO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47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9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9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51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4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4247859241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Gibbsite [Al(OH)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617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522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433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364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03816404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aghemite [Fe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O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</a:t>
                          </a:r>
                          <a:r>
                            <a:rPr lang="en-US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  <a:endParaRPr lang="en-US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5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512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6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73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3802289506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5" name="Table 4">
                <a:extLst>
                  <a:ext uri="{FF2B5EF4-FFF2-40B4-BE49-F238E27FC236}">
                    <a16:creationId xmlns:a16="http://schemas.microsoft.com/office/drawing/2014/main" id="{D31328EC-656B-AA45-8C4A-B480A2D7D854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2900898849"/>
                  </p:ext>
                </p:extLst>
              </p:nvPr>
            </p:nvGraphicFramePr>
            <p:xfrm>
              <a:off x="574662" y="2064639"/>
              <a:ext cx="5852769" cy="3601720"/>
            </p:xfrm>
            <a:graphic>
              <a:graphicData uri="http://schemas.openxmlformats.org/drawingml/2006/table">
                <a:tbl>
                  <a:tblPr firstRow="1" bandRow="1">
                    <a:tableStyleId>{5940675A-B579-460E-94D1-54222C63F5DA}</a:tableStyleId>
                  </a:tblPr>
                  <a:tblGrid>
                    <a:gridCol w="1789811">
                      <a:extLst>
                        <a:ext uri="{9D8B030D-6E8A-4147-A177-3AD203B41FA5}">
                          <a16:colId xmlns:a16="http://schemas.microsoft.com/office/drawing/2014/main" val="747991374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739714215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45241243"/>
                        </a:ext>
                      </a:extLst>
                    </a:gridCol>
                    <a:gridCol w="797243">
                      <a:extLst>
                        <a:ext uri="{9D8B030D-6E8A-4147-A177-3AD203B41FA5}">
                          <a16:colId xmlns:a16="http://schemas.microsoft.com/office/drawing/2014/main" val="3087449460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3246340764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1171635718"/>
                        </a:ext>
                      </a:extLst>
                    </a:gridCol>
                    <a:gridCol w="653143">
                      <a:extLst>
                        <a:ext uri="{9D8B030D-6E8A-4147-A177-3AD203B41FA5}">
                          <a16:colId xmlns:a16="http://schemas.microsoft.com/office/drawing/2014/main" val="1484073801"/>
                        </a:ext>
                      </a:extLst>
                    </a:gridCol>
                  </a:tblGrid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inerals in samples</a:t>
                          </a:r>
                        </a:p>
                      </a:txBody>
                      <a:tcPr/>
                    </a:tc>
                    <a:tc gridSpan="6"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Wavenumbers (cm</a:t>
                          </a:r>
                          <a:r>
                            <a:rPr lang="en-US" baseline="30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1</a:t>
                          </a:r>
                          <a:r>
                            <a:rPr lang="en-US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)</a:t>
                          </a:r>
                          <a:endParaRPr lang="en-US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 dirty="0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398875660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Goethite [α-</a:t>
                          </a:r>
                          <a:r>
                            <a:rPr lang="en-US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FeOOH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44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99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8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48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54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81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2308452441"/>
                      </a:ext>
                    </a:extLst>
                  </a:tr>
                  <a:tr h="50292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blipFill>
                          <a:blip r:embed="rId2"/>
                          <a:stretch>
                            <a:fillRect l="-709" t="-153846" r="-227660" b="-479487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5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4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79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52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5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2623539500"/>
                      </a:ext>
                    </a:extLst>
                  </a:tr>
                  <a:tr h="50292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ssociated minerals not observed</a:t>
                          </a:r>
                        </a:p>
                      </a:txBody>
                      <a:tcPr/>
                    </a:tc>
                    <a:tc gridSpan="6">
                      <a:txBody>
                        <a:bodyPr/>
                        <a:lstStyle/>
                        <a:p>
                          <a:pPr algn="ctr"/>
                          <a:endParaRPr lang="en-US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76155384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Hematite [Fe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O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</a:t>
                          </a:r>
                          <a:r>
                            <a:rPr lang="en-US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  <a:endParaRPr lang="en-US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2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4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90-30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412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3093942682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Rutile [TiO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44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12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2230308384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marL="0" marR="0" lvl="0" indent="0" algn="ctr" defTabSz="6858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atase [TiO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47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9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98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51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4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4247859241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Gibbsite [Al(OH)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617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522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433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364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03816404"/>
                      </a:ext>
                    </a:extLst>
                  </a:tr>
                  <a:tr h="37084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Maghemite [Fe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</a:t>
                          </a:r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O</a:t>
                          </a:r>
                          <a:r>
                            <a:rPr lang="en-US" baseline="-25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</a:t>
                          </a:r>
                          <a:r>
                            <a:rPr lang="en-US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]</a:t>
                          </a:r>
                          <a:endParaRPr lang="en-US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5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512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65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730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</a:t>
                          </a:r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3802289506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7" name="Rectangle 6">
            <a:extLst>
              <a:ext uri="{FF2B5EF4-FFF2-40B4-BE49-F238E27FC236}">
                <a16:creationId xmlns:a16="http://schemas.microsoft.com/office/drawing/2014/main" id="{19A59E87-7916-3140-B2D4-C5792EDE483F}"/>
              </a:ext>
            </a:extLst>
          </p:cNvPr>
          <p:cNvSpPr/>
          <p:nvPr/>
        </p:nvSpPr>
        <p:spPr>
          <a:xfrm>
            <a:off x="574663" y="5921121"/>
            <a:ext cx="585276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nesch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 (2009). Raman spectroscopy of iron oxides and (oxy) hydroxides at low laser 	power and possible applications in environmental magnetic studies. Geophysical 	Journal International, 177(3), 941-948.</a:t>
            </a:r>
          </a:p>
          <a:p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aña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, Garcia‐Ramos, J. V., &amp; Serna, C. J. (1992). Low‐temperature nucleation of rutile 	observed by Raman spectroscopy during crystallization of TiO</a:t>
            </a:r>
            <a:r>
              <a:rPr lang="en-AU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 Journal of the 	American Ceramic Society, 75(7), 2010-2012.</a:t>
            </a:r>
          </a:p>
          <a:p>
            <a:r>
              <a:rPr lang="en-AU" sz="1200" dirty="0" err="1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uan</a:t>
            </a:r>
            <a:r>
              <a:rPr lang="en-AU" sz="12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H. D., Frost, R. L., &amp; </a:t>
            </a:r>
            <a:r>
              <a:rPr lang="en-AU" sz="1200" dirty="0" err="1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loprogge</a:t>
            </a:r>
            <a:r>
              <a:rPr lang="en-AU" sz="12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J. T. (2001). Comparison of Raman spectra in 	characterizing gibbsite, bayerite, diaspore and boehmite. Journal of Raman 	Spectroscopy, 32(9), 745-750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492828F-E878-2D41-B0E2-5F1AEA6425E1}"/>
              </a:ext>
            </a:extLst>
          </p:cNvPr>
          <p:cNvSpPr/>
          <p:nvPr/>
        </p:nvSpPr>
        <p:spPr>
          <a:xfrm>
            <a:off x="574662" y="815889"/>
            <a:ext cx="596562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List of minerals identified in canga samples using Raman spectroscopy. Bands for iron oxide minerals are from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nesch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09), bands for titanium oxide minerals are from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añ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 (1992) and bands for gibbsite are from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a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 (2001)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4103921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617A9598-E984-C34D-9B9F-6ABE89FD47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/>
          <a:stretch/>
        </p:blipFill>
        <p:spPr>
          <a:xfrm>
            <a:off x="459000" y="655549"/>
            <a:ext cx="5939998" cy="3651120"/>
          </a:xfrm>
          <a:prstGeom prst="rect">
            <a:avLst/>
          </a:prstGeom>
          <a:ln w="28575"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548316D-18EB-634F-84E9-9BCA3CE7A8CF}"/>
              </a:ext>
            </a:extLst>
          </p:cNvPr>
          <p:cNvSpPr txBox="1"/>
          <p:nvPr/>
        </p:nvSpPr>
        <p:spPr>
          <a:xfrm>
            <a:off x="3899647" y="3202888"/>
            <a:ext cx="2499351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e spectru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C5C3E7C-F5EC-2649-8920-56EBBFDC385B}"/>
              </a:ext>
            </a:extLst>
          </p:cNvPr>
          <p:cNvSpPr txBox="1"/>
          <p:nvPr/>
        </p:nvSpPr>
        <p:spPr>
          <a:xfrm>
            <a:off x="3361765" y="1930158"/>
            <a:ext cx="3037233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rnal goethite standar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96D6F21-E76D-B444-B432-B879925AF765}"/>
              </a:ext>
            </a:extLst>
          </p:cNvPr>
          <p:cNvSpPr txBox="1"/>
          <p:nvPr/>
        </p:nvSpPr>
        <p:spPr>
          <a:xfrm>
            <a:off x="3361765" y="588014"/>
            <a:ext cx="3037233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rnal goethite standar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751B6E5-EA3D-7F4F-B85A-E1FCB2EBAD10}"/>
              </a:ext>
            </a:extLst>
          </p:cNvPr>
          <p:cNvSpPr txBox="1"/>
          <p:nvPr/>
        </p:nvSpPr>
        <p:spPr>
          <a:xfrm>
            <a:off x="458999" y="588013"/>
            <a:ext cx="2902766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e ma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D5D8BD2-4708-E14D-9135-D7C1D35F6E7E}"/>
              </a:ext>
            </a:extLst>
          </p:cNvPr>
          <p:cNvSpPr txBox="1"/>
          <p:nvPr/>
        </p:nvSpPr>
        <p:spPr>
          <a:xfrm>
            <a:off x="458999" y="2657677"/>
            <a:ext cx="1495307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pidocrocite ma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454B66-740C-3546-92FB-A69F48CD0C40}"/>
              </a:ext>
            </a:extLst>
          </p:cNvPr>
          <p:cNvSpPr txBox="1"/>
          <p:nvPr/>
        </p:nvSpPr>
        <p:spPr>
          <a:xfrm>
            <a:off x="1954306" y="2657677"/>
            <a:ext cx="1495307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oethite map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B48D583-87F3-9245-8CE4-1FB0B13E702D}"/>
              </a:ext>
            </a:extLst>
          </p:cNvPr>
          <p:cNvSpPr/>
          <p:nvPr/>
        </p:nvSpPr>
        <p:spPr>
          <a:xfrm>
            <a:off x="458998" y="588013"/>
            <a:ext cx="5940000" cy="454965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58B4B6C-4AC4-CE4D-BEB3-197C68652BE8}"/>
              </a:ext>
            </a:extLst>
          </p:cNvPr>
          <p:cNvSpPr/>
          <p:nvPr/>
        </p:nvSpPr>
        <p:spPr>
          <a:xfrm>
            <a:off x="458997" y="2657677"/>
            <a:ext cx="2990615" cy="16562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749FB12-98F9-0644-A7D7-5968DA237FEC}"/>
              </a:ext>
            </a:extLst>
          </p:cNvPr>
          <p:cNvSpPr txBox="1"/>
          <p:nvPr/>
        </p:nvSpPr>
        <p:spPr>
          <a:xfrm>
            <a:off x="458999" y="4306669"/>
            <a:ext cx="5939999" cy="830997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 ‘Live spectrum’ shows a representative spectrum of goethite taken from cross-hairs of the ‘Live map’, which was generated by integrating each spectrum between 370 and 430 c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lease note, goethite and lepidocrocite maps were generated using classical least squares (CLS) method (see Raman methods in manuscript for details). </a:t>
            </a:r>
          </a:p>
        </p:txBody>
      </p:sp>
    </p:spTree>
    <p:extLst>
      <p:ext uri="{BB962C8B-B14F-4D97-AF65-F5344CB8AC3E}">
        <p14:creationId xmlns:p14="http://schemas.microsoft.com/office/powerpoint/2010/main" val="33876318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A4DE7C12-2426-8C4A-8C83-B362174812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613" y="682970"/>
            <a:ext cx="5940000" cy="365112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FEBFD83-BE42-FF47-A0BA-55C44CEB0317}"/>
              </a:ext>
            </a:extLst>
          </p:cNvPr>
          <p:cNvSpPr txBox="1"/>
          <p:nvPr/>
        </p:nvSpPr>
        <p:spPr>
          <a:xfrm>
            <a:off x="458999" y="4313926"/>
            <a:ext cx="5939999" cy="830997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. ‘Live spectrum’ shows a representative spectrum of lepidocrocite taken from cross-hairs of the ‘Live map’, which was generated by integrating each spectrum between 230 and 270 c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lease note, goethite and lepidocrocite maps were generated using classical least squares (CLS) method (see Raman methods in manuscript for details)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CC25D00-DD95-6D4D-A9BC-588CA5D8DCB6}"/>
              </a:ext>
            </a:extLst>
          </p:cNvPr>
          <p:cNvSpPr txBox="1"/>
          <p:nvPr/>
        </p:nvSpPr>
        <p:spPr>
          <a:xfrm>
            <a:off x="3899647" y="3202888"/>
            <a:ext cx="2499351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e spectru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1AD78BE-1A27-6240-9B15-F363CE33B96F}"/>
              </a:ext>
            </a:extLst>
          </p:cNvPr>
          <p:cNvSpPr txBox="1"/>
          <p:nvPr/>
        </p:nvSpPr>
        <p:spPr>
          <a:xfrm>
            <a:off x="3361765" y="1930158"/>
            <a:ext cx="3037233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rnal goethite standar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750E55C-362F-344E-AD3A-64503B4775BE}"/>
              </a:ext>
            </a:extLst>
          </p:cNvPr>
          <p:cNvSpPr txBox="1"/>
          <p:nvPr/>
        </p:nvSpPr>
        <p:spPr>
          <a:xfrm>
            <a:off x="3361765" y="588014"/>
            <a:ext cx="3037233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rnal goethite standar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F75D89D-7190-E147-B130-3943CE53C333}"/>
              </a:ext>
            </a:extLst>
          </p:cNvPr>
          <p:cNvSpPr txBox="1"/>
          <p:nvPr/>
        </p:nvSpPr>
        <p:spPr>
          <a:xfrm>
            <a:off x="458999" y="588013"/>
            <a:ext cx="2902766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ve ma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C20732E-F785-234B-9C94-2D93E022B469}"/>
              </a:ext>
            </a:extLst>
          </p:cNvPr>
          <p:cNvSpPr txBox="1"/>
          <p:nvPr/>
        </p:nvSpPr>
        <p:spPr>
          <a:xfrm>
            <a:off x="458999" y="2657677"/>
            <a:ext cx="1495307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pidocrocite ma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B229790-0640-034C-BC6C-79B1A55C5667}"/>
              </a:ext>
            </a:extLst>
          </p:cNvPr>
          <p:cNvSpPr txBox="1"/>
          <p:nvPr/>
        </p:nvSpPr>
        <p:spPr>
          <a:xfrm>
            <a:off x="1954305" y="2657677"/>
            <a:ext cx="1529123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oethite map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79C6356-E95D-B74F-ADC8-96D622DF288B}"/>
              </a:ext>
            </a:extLst>
          </p:cNvPr>
          <p:cNvSpPr/>
          <p:nvPr/>
        </p:nvSpPr>
        <p:spPr>
          <a:xfrm>
            <a:off x="458998" y="588013"/>
            <a:ext cx="5940000" cy="454965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1B0ED64-906F-5F4F-99E9-4FCF50E0581C}"/>
              </a:ext>
            </a:extLst>
          </p:cNvPr>
          <p:cNvSpPr/>
          <p:nvPr/>
        </p:nvSpPr>
        <p:spPr>
          <a:xfrm>
            <a:off x="479613" y="2657677"/>
            <a:ext cx="3003815" cy="16562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1349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6B567B7-ED73-5B4A-A2D6-60E3927E4BE1}"/>
              </a:ext>
            </a:extLst>
          </p:cNvPr>
          <p:cNvSpPr txBox="1"/>
          <p:nvPr/>
        </p:nvSpPr>
        <p:spPr>
          <a:xfrm>
            <a:off x="458999" y="7846151"/>
            <a:ext cx="593999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3. Backscattered scanning electron micrograph providing examples of </a:t>
            </a:r>
            <a:r>
              <a:rPr lang="en-AU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rcina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ike multicellular packets fossilised within an iron-rich duricrust in Carajás Mineral Deposit, Pará, Brazil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A27B408-D381-BB44-A62D-8C42E70BF24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" contrast="25000"/>
                    </a14:imgEffect>
                  </a14:imgLayer>
                </a14:imgProps>
              </a:ext>
            </a:extLst>
          </a:blip>
          <a:srcRect l="17007" t="31099" r="48168" b="20805"/>
          <a:stretch/>
        </p:blipFill>
        <p:spPr>
          <a:xfrm>
            <a:off x="460800" y="1076400"/>
            <a:ext cx="5940000" cy="656280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C5FBB9A2-16BA-9248-8309-441C492B7A8C}"/>
              </a:ext>
            </a:extLst>
          </p:cNvPr>
          <p:cNvCxnSpPr/>
          <p:nvPr/>
        </p:nvCxnSpPr>
        <p:spPr>
          <a:xfrm flipH="1" flipV="1">
            <a:off x="1847461" y="3349690"/>
            <a:ext cx="578498" cy="60649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  <a:effectLst>
            <a:glow rad="12700">
              <a:schemeClr val="bg1"/>
            </a:glow>
            <a:softEdge rad="0"/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3EBB607-85C3-C245-8BDB-50E8B62E4A6A}"/>
              </a:ext>
            </a:extLst>
          </p:cNvPr>
          <p:cNvCxnSpPr>
            <a:cxnSpLocks/>
          </p:cNvCxnSpPr>
          <p:nvPr/>
        </p:nvCxnSpPr>
        <p:spPr>
          <a:xfrm>
            <a:off x="4450702" y="6494106"/>
            <a:ext cx="391886" cy="38255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  <a:effectLst>
            <a:glow rad="12700">
              <a:schemeClr val="bg1"/>
            </a:glow>
            <a:softEdge rad="0"/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>
            <a:extLst>
              <a:ext uri="{FF2B5EF4-FFF2-40B4-BE49-F238E27FC236}">
                <a16:creationId xmlns:a16="http://schemas.microsoft.com/office/drawing/2014/main" id="{E1EC03C7-C923-4B4C-AA32-6C290AA8C7A0}"/>
              </a:ext>
            </a:extLst>
          </p:cNvPr>
          <p:cNvSpPr/>
          <p:nvPr/>
        </p:nvSpPr>
        <p:spPr>
          <a:xfrm>
            <a:off x="562091" y="7251631"/>
            <a:ext cx="1206000" cy="108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A9AB280-159C-7D41-92FC-873F71FE2829}"/>
              </a:ext>
            </a:extLst>
          </p:cNvPr>
          <p:cNvSpPr txBox="1"/>
          <p:nvPr/>
        </p:nvSpPr>
        <p:spPr>
          <a:xfrm>
            <a:off x="562091" y="6877354"/>
            <a:ext cx="120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dirty="0">
                <a:solidFill>
                  <a:schemeClr val="bg1"/>
                </a:solidFill>
                <a:effectLst>
                  <a:glow rad="25400">
                    <a:schemeClr val="tx1"/>
                  </a:glo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5 µm</a:t>
            </a:r>
          </a:p>
        </p:txBody>
      </p:sp>
    </p:spTree>
    <p:extLst>
      <p:ext uri="{BB962C8B-B14F-4D97-AF65-F5344CB8AC3E}">
        <p14:creationId xmlns:p14="http://schemas.microsoft.com/office/powerpoint/2010/main" val="3532426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5</TotalTime>
  <Words>517</Words>
  <Application>Microsoft Macintosh PowerPoint</Application>
  <PresentationFormat>A4 Paper (210x297 mm)</PresentationFormat>
  <Paragraphs>84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Levett</dc:creator>
  <cp:lastModifiedBy>Alan Levett</cp:lastModifiedBy>
  <cp:revision>17</cp:revision>
  <dcterms:created xsi:type="dcterms:W3CDTF">2020-01-15T10:48:10Z</dcterms:created>
  <dcterms:modified xsi:type="dcterms:W3CDTF">2020-05-20T06:32:43Z</dcterms:modified>
</cp:coreProperties>
</file>